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6858000" cy="9906000" type="A4"/>
  <p:notesSz cx="6669088" cy="98726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90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21" autoAdjust="0"/>
    <p:restoredTop sz="94660"/>
  </p:normalViewPr>
  <p:slideViewPr>
    <p:cSldViewPr snapToGrid="0">
      <p:cViewPr>
        <p:scale>
          <a:sx n="178" d="100"/>
          <a:sy n="178" d="100"/>
        </p:scale>
        <p:origin x="1856" y="-228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938" cy="49534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777607" y="0"/>
            <a:ext cx="2889938" cy="49534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3535F8-AFC1-43F9-AE97-2504093E3699}" type="datetimeFigureOut">
              <a:rPr lang="en-GB" smtClean="0"/>
              <a:t>09/08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81225" y="1233488"/>
            <a:ext cx="2306638" cy="33321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66909" y="4751219"/>
            <a:ext cx="5335270" cy="38873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7317"/>
            <a:ext cx="2889938" cy="49534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777607" y="9377317"/>
            <a:ext cx="2889938" cy="49534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9B7139-A2DF-4EC3-813E-EA7B28B15A1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31784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6FB10-8CB5-4BA3-BB36-631F85A06374}" type="datetimeFigureOut">
              <a:rPr lang="en-GB" smtClean="0"/>
              <a:t>09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EC875-74FC-42D6-A3A8-A1DE14A58C1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4518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6FB10-8CB5-4BA3-BB36-631F85A06374}" type="datetimeFigureOut">
              <a:rPr lang="en-GB" smtClean="0"/>
              <a:t>09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EC875-74FC-42D6-A3A8-A1DE14A58C1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37892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6FB10-8CB5-4BA3-BB36-631F85A06374}" type="datetimeFigureOut">
              <a:rPr lang="en-GB" smtClean="0"/>
              <a:t>09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EC875-74FC-42D6-A3A8-A1DE14A58C1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06850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6FB10-8CB5-4BA3-BB36-631F85A06374}" type="datetimeFigureOut">
              <a:rPr lang="en-GB" smtClean="0"/>
              <a:t>09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EC875-74FC-42D6-A3A8-A1DE14A58C1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19783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6FB10-8CB5-4BA3-BB36-631F85A06374}" type="datetimeFigureOut">
              <a:rPr lang="en-GB" smtClean="0"/>
              <a:t>09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EC875-74FC-42D6-A3A8-A1DE14A58C1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9062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6FB10-8CB5-4BA3-BB36-631F85A06374}" type="datetimeFigureOut">
              <a:rPr lang="en-GB" smtClean="0"/>
              <a:t>09/08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EC875-74FC-42D6-A3A8-A1DE14A58C1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27078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6FB10-8CB5-4BA3-BB36-631F85A06374}" type="datetimeFigureOut">
              <a:rPr lang="en-GB" smtClean="0"/>
              <a:t>09/08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EC875-74FC-42D6-A3A8-A1DE14A58C1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0658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6FB10-8CB5-4BA3-BB36-631F85A06374}" type="datetimeFigureOut">
              <a:rPr lang="en-GB" smtClean="0"/>
              <a:t>09/08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EC875-74FC-42D6-A3A8-A1DE14A58C1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9801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6FB10-8CB5-4BA3-BB36-631F85A06374}" type="datetimeFigureOut">
              <a:rPr lang="en-GB" smtClean="0"/>
              <a:t>09/08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EC875-74FC-42D6-A3A8-A1DE14A58C1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15815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6FB10-8CB5-4BA3-BB36-631F85A06374}" type="datetimeFigureOut">
              <a:rPr lang="en-GB" smtClean="0"/>
              <a:t>09/08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EC875-74FC-42D6-A3A8-A1DE14A58C1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2816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96FB10-8CB5-4BA3-BB36-631F85A06374}" type="datetimeFigureOut">
              <a:rPr lang="en-GB" smtClean="0"/>
              <a:t>09/08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EEC875-74FC-42D6-A3A8-A1DE14A58C1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23463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96FB10-8CB5-4BA3-BB36-631F85A06374}" type="datetimeFigureOut">
              <a:rPr lang="en-GB" smtClean="0"/>
              <a:t>09/08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EEC875-74FC-42D6-A3A8-A1DE14A58C1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71045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 descr="F:\To move\Revue uréase\Phylogénie revue\Phylogénie des UC.png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666" t="15082"/>
          <a:stretch/>
        </p:blipFill>
        <p:spPr bwMode="auto">
          <a:xfrm>
            <a:off x="3441718" y="3379826"/>
            <a:ext cx="3240000" cy="34279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3" name="Groupe 2"/>
          <p:cNvGrpSpPr/>
          <p:nvPr/>
        </p:nvGrpSpPr>
        <p:grpSpPr>
          <a:xfrm>
            <a:off x="87418" y="116511"/>
            <a:ext cx="3240000" cy="6691257"/>
            <a:chOff x="-1" y="537091"/>
            <a:chExt cx="3240000" cy="6691257"/>
          </a:xfrm>
        </p:grpSpPr>
        <p:pic>
          <p:nvPicPr>
            <p:cNvPr id="1027" name="Picture 3" descr="F:\To move\Revue uréase\Phylogénie revue\Phylogénie des UreC.png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713" t="5958"/>
            <a:stretch/>
          </p:blipFill>
          <p:spPr bwMode="auto">
            <a:xfrm>
              <a:off x="-1" y="537091"/>
              <a:ext cx="3240000" cy="669125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ZoneTexte 1"/>
            <p:cNvSpPr txBox="1"/>
            <p:nvPr/>
          </p:nvSpPr>
          <p:spPr>
            <a:xfrm>
              <a:off x="2266950" y="697468"/>
              <a:ext cx="407484" cy="46166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>
                  <a:lumMod val="50000"/>
                </a:schemeClr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fr-FR" sz="2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</p:grpSp>
      <p:sp>
        <p:nvSpPr>
          <p:cNvPr id="12" name="ZoneTexte 11"/>
          <p:cNvSpPr txBox="1"/>
          <p:nvPr/>
        </p:nvSpPr>
        <p:spPr>
          <a:xfrm>
            <a:off x="5518168" y="3206759"/>
            <a:ext cx="389850" cy="461665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50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fr-FR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0" y="7085577"/>
            <a:ext cx="6858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stribution of 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coding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reas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reC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unit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anel 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ophanat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ydrolase (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rea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rboxylase (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tein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riou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ganisms</a:t>
            </a:r>
            <a:endParaRPr lang="fr-F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ee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r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struct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al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mega,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ing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9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reC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ecie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he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anobacterial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hylum (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ghlight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green), or all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sently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ied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coding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ither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ophanate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>
                <a:latin typeface="Times New Roman" panose="02020603050405020304" pitchFamily="18" charset="0"/>
                <a:cs typeface="Times New Roman" panose="02020603050405020304" pitchFamily="18" charset="0"/>
              </a:rPr>
              <a:t>hydrolase or </a:t>
            </a:r>
            <a:r>
              <a:rPr lang="fr-F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rea</a:t>
            </a:r>
            <a:r>
              <a:rPr lang="fr-F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rboxylase.</a:t>
            </a:r>
          </a:p>
          <a:p>
            <a:pPr algn="just"/>
            <a:endParaRPr lang="fr-FR" sz="1200" dirty="0">
              <a:solidFill>
                <a:srgbClr val="0903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30" name="Picture 6" descr="F:\To move\Revue uréase\Phylogénie revue\Phylogénie des AH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68" t="21261"/>
          <a:stretch/>
        </p:blipFill>
        <p:spPr bwMode="auto">
          <a:xfrm>
            <a:off x="3213118" y="118724"/>
            <a:ext cx="3240000" cy="24530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ZoneTexte 9"/>
          <p:cNvSpPr txBox="1"/>
          <p:nvPr/>
        </p:nvSpPr>
        <p:spPr>
          <a:xfrm>
            <a:off x="5337193" y="252074"/>
            <a:ext cx="389850" cy="461665"/>
          </a:xfrm>
          <a:prstGeom prst="rect">
            <a:avLst/>
          </a:prstGeom>
          <a:solidFill>
            <a:schemeClr val="bg1"/>
          </a:solidFill>
          <a:ln>
            <a:solidFill>
              <a:schemeClr val="bg1">
                <a:lumMod val="50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fr-FR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9457440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3</TotalTime>
  <Words>74</Words>
  <Application>Microsoft Macintosh PowerPoint</Application>
  <PresentationFormat>Format A4 (210 x 297 mm)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éo Veaudor</dc:creator>
  <cp:lastModifiedBy>Franck Chauvat</cp:lastModifiedBy>
  <cp:revision>11</cp:revision>
  <cp:lastPrinted>2019-08-09T08:27:38Z</cp:lastPrinted>
  <dcterms:created xsi:type="dcterms:W3CDTF">2019-08-08T16:32:02Z</dcterms:created>
  <dcterms:modified xsi:type="dcterms:W3CDTF">2019-08-09T11:45:09Z</dcterms:modified>
</cp:coreProperties>
</file>